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1" r:id="rId2"/>
    <p:sldId id="258" r:id="rId3"/>
    <p:sldId id="278" r:id="rId4"/>
    <p:sldId id="281" r:id="rId5"/>
    <p:sldId id="282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024" autoAdjust="0"/>
    <p:restoredTop sz="94660"/>
  </p:normalViewPr>
  <p:slideViewPr>
    <p:cSldViewPr snapToGrid="0">
      <p:cViewPr varScale="1">
        <p:scale>
          <a:sx n="92" d="100"/>
          <a:sy n="92" d="100"/>
        </p:scale>
        <p:origin x="4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yandie\Desktop\&#25176;&#29664;&#21333;&#25239;&#27835;&#30103;&#33258;&#36523;&#28814;&#30151;&#24615;&#30142;&#30149;\&#22270;&#29255;\&#27766;&#24847;&#38387;%20-%20&#21103;&#264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yandie\Desktop\&#25176;&#29664;&#21333;&#25239;&#27835;&#30103;&#33258;&#36523;&#28814;&#30151;&#24615;&#30142;&#30149;\2022.12&#25176;&#29664;&#21333;&#25239;&#27835;&#30103;&#33258;&#36523;&#28814;&#30151;&#24615;&#30142;&#30149;\&#22270;&#29255;\&#27766;&#24847;&#38387;%20-%20&#21103;&#264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yandie\Desktop\&#25176;&#29664;&#21333;&#25239;&#27835;&#30103;&#33258;&#36523;&#28814;&#30151;&#24615;&#30142;&#30149;\&#22270;&#29255;\&#24352;&#25991;&#28009;%20-%20&#21103;&#26412;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yandie\Desktop\&#25176;&#29664;&#21333;&#25239;&#27835;&#30103;&#33258;&#36523;&#28814;&#30151;&#24615;&#30142;&#30149;\2022.12&#25176;&#29664;&#21333;&#25239;&#27835;&#30103;&#33258;&#36523;&#28814;&#30151;&#24615;&#30142;&#30149;\&#22270;&#29255;\&#24352;&#25991;&#28009;%20-%20&#21103;&#26412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2459394827825632E-2"/>
          <c:y val="3.7976510633775523E-2"/>
          <c:w val="0.94189809506361533"/>
          <c:h val="0.68494267400067499"/>
        </c:manualLayout>
      </c:layout>
      <c:lineChart>
        <c:grouping val="standar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WBC（x10^9/L）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Sheet1!$B$3:$B$32</c:f>
              <c:strCache>
                <c:ptCount val="30"/>
                <c:pt idx="0">
                  <c:v>120week</c:v>
                </c:pt>
                <c:pt idx="1">
                  <c:v>100week</c:v>
                </c:pt>
                <c:pt idx="2">
                  <c:v>80week</c:v>
                </c:pt>
                <c:pt idx="3">
                  <c:v>60week</c:v>
                </c:pt>
                <c:pt idx="4">
                  <c:v>40week</c:v>
                </c:pt>
                <c:pt idx="5">
                  <c:v>20week</c:v>
                </c:pt>
                <c:pt idx="6">
                  <c:v>10week</c:v>
                </c:pt>
                <c:pt idx="7">
                  <c:v>0week</c:v>
                </c:pt>
                <c:pt idx="8">
                  <c:v>1week</c:v>
                </c:pt>
                <c:pt idx="9">
                  <c:v>3week</c:v>
                </c:pt>
                <c:pt idx="10">
                  <c:v>6week</c:v>
                </c:pt>
                <c:pt idx="11">
                  <c:v>9week</c:v>
                </c:pt>
                <c:pt idx="12">
                  <c:v>12week</c:v>
                </c:pt>
                <c:pt idx="13">
                  <c:v>15week</c:v>
                </c:pt>
                <c:pt idx="14">
                  <c:v>18week</c:v>
                </c:pt>
                <c:pt idx="15">
                  <c:v>21week</c:v>
                </c:pt>
                <c:pt idx="16">
                  <c:v>24week</c:v>
                </c:pt>
                <c:pt idx="17">
                  <c:v>27week</c:v>
                </c:pt>
                <c:pt idx="18">
                  <c:v>30week</c:v>
                </c:pt>
                <c:pt idx="19">
                  <c:v>33week</c:v>
                </c:pt>
                <c:pt idx="20">
                  <c:v>34week</c:v>
                </c:pt>
                <c:pt idx="21">
                  <c:v>39week</c:v>
                </c:pt>
                <c:pt idx="22">
                  <c:v>42week</c:v>
                </c:pt>
                <c:pt idx="23">
                  <c:v>45week</c:v>
                </c:pt>
                <c:pt idx="24">
                  <c:v>48week</c:v>
                </c:pt>
                <c:pt idx="25">
                  <c:v>51week</c:v>
                </c:pt>
                <c:pt idx="26">
                  <c:v>54week</c:v>
                </c:pt>
                <c:pt idx="27">
                  <c:v>57week</c:v>
                </c:pt>
                <c:pt idx="28">
                  <c:v>60week</c:v>
                </c:pt>
                <c:pt idx="29">
                  <c:v>63week</c:v>
                </c:pt>
              </c:strCache>
            </c:strRef>
          </c:cat>
          <c:val>
            <c:numRef>
              <c:f>Sheet1!$C$3:$C$32</c:f>
              <c:numCache>
                <c:formatCode>General</c:formatCode>
                <c:ptCount val="30"/>
                <c:pt idx="0">
                  <c:v>9.68</c:v>
                </c:pt>
                <c:pt idx="1">
                  <c:v>5.87</c:v>
                </c:pt>
                <c:pt idx="2">
                  <c:v>5.01</c:v>
                </c:pt>
                <c:pt idx="3">
                  <c:v>7.89</c:v>
                </c:pt>
                <c:pt idx="4">
                  <c:v>7.94</c:v>
                </c:pt>
                <c:pt idx="5">
                  <c:v>7.94</c:v>
                </c:pt>
                <c:pt idx="6">
                  <c:v>10.69</c:v>
                </c:pt>
                <c:pt idx="7">
                  <c:v>10.14</c:v>
                </c:pt>
                <c:pt idx="8">
                  <c:v>3.74</c:v>
                </c:pt>
                <c:pt idx="9">
                  <c:v>5.78</c:v>
                </c:pt>
                <c:pt idx="10">
                  <c:v>6.39</c:v>
                </c:pt>
                <c:pt idx="11">
                  <c:v>11.26</c:v>
                </c:pt>
                <c:pt idx="12">
                  <c:v>9.41</c:v>
                </c:pt>
                <c:pt idx="13">
                  <c:v>7.11</c:v>
                </c:pt>
                <c:pt idx="14">
                  <c:v>6.96</c:v>
                </c:pt>
                <c:pt idx="15">
                  <c:v>7.07</c:v>
                </c:pt>
                <c:pt idx="16">
                  <c:v>6.1</c:v>
                </c:pt>
                <c:pt idx="17">
                  <c:v>6.82</c:v>
                </c:pt>
                <c:pt idx="18">
                  <c:v>5.33</c:v>
                </c:pt>
                <c:pt idx="19">
                  <c:v>5.99</c:v>
                </c:pt>
                <c:pt idx="20">
                  <c:v>5.91</c:v>
                </c:pt>
                <c:pt idx="21">
                  <c:v>7.43</c:v>
                </c:pt>
                <c:pt idx="22">
                  <c:v>7.84</c:v>
                </c:pt>
                <c:pt idx="23">
                  <c:v>6.19</c:v>
                </c:pt>
                <c:pt idx="24">
                  <c:v>6.12</c:v>
                </c:pt>
                <c:pt idx="25">
                  <c:v>7.42</c:v>
                </c:pt>
                <c:pt idx="26">
                  <c:v>6.46</c:v>
                </c:pt>
                <c:pt idx="27">
                  <c:v>4.01</c:v>
                </c:pt>
                <c:pt idx="28">
                  <c:v>4.12</c:v>
                </c:pt>
                <c:pt idx="29">
                  <c:v>11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BB3-4D01-A5EA-3FD8EE11EC1B}"/>
            </c:ext>
          </c:extLst>
        </c:ser>
        <c:ser>
          <c:idx val="1"/>
          <c:order val="1"/>
          <c:tx>
            <c:strRef>
              <c:f>Sheet1!$D$2</c:f>
              <c:strCache>
                <c:ptCount val="1"/>
                <c:pt idx="0">
                  <c:v>CRP（mg/L）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Sheet1!$B$3:$B$32</c:f>
              <c:strCache>
                <c:ptCount val="30"/>
                <c:pt idx="0">
                  <c:v>120week</c:v>
                </c:pt>
                <c:pt idx="1">
                  <c:v>100week</c:v>
                </c:pt>
                <c:pt idx="2">
                  <c:v>80week</c:v>
                </c:pt>
                <c:pt idx="3">
                  <c:v>60week</c:v>
                </c:pt>
                <c:pt idx="4">
                  <c:v>40week</c:v>
                </c:pt>
                <c:pt idx="5">
                  <c:v>20week</c:v>
                </c:pt>
                <c:pt idx="6">
                  <c:v>10week</c:v>
                </c:pt>
                <c:pt idx="7">
                  <c:v>0week</c:v>
                </c:pt>
                <c:pt idx="8">
                  <c:v>1week</c:v>
                </c:pt>
                <c:pt idx="9">
                  <c:v>3week</c:v>
                </c:pt>
                <c:pt idx="10">
                  <c:v>6week</c:v>
                </c:pt>
                <c:pt idx="11">
                  <c:v>9week</c:v>
                </c:pt>
                <c:pt idx="12">
                  <c:v>12week</c:v>
                </c:pt>
                <c:pt idx="13">
                  <c:v>15week</c:v>
                </c:pt>
                <c:pt idx="14">
                  <c:v>18week</c:v>
                </c:pt>
                <c:pt idx="15">
                  <c:v>21week</c:v>
                </c:pt>
                <c:pt idx="16">
                  <c:v>24week</c:v>
                </c:pt>
                <c:pt idx="17">
                  <c:v>27week</c:v>
                </c:pt>
                <c:pt idx="18">
                  <c:v>30week</c:v>
                </c:pt>
                <c:pt idx="19">
                  <c:v>33week</c:v>
                </c:pt>
                <c:pt idx="20">
                  <c:v>34week</c:v>
                </c:pt>
                <c:pt idx="21">
                  <c:v>39week</c:v>
                </c:pt>
                <c:pt idx="22">
                  <c:v>42week</c:v>
                </c:pt>
                <c:pt idx="23">
                  <c:v>45week</c:v>
                </c:pt>
                <c:pt idx="24">
                  <c:v>48week</c:v>
                </c:pt>
                <c:pt idx="25">
                  <c:v>51week</c:v>
                </c:pt>
                <c:pt idx="26">
                  <c:v>54week</c:v>
                </c:pt>
                <c:pt idx="27">
                  <c:v>57week</c:v>
                </c:pt>
                <c:pt idx="28">
                  <c:v>60week</c:v>
                </c:pt>
                <c:pt idx="29">
                  <c:v>63week</c:v>
                </c:pt>
              </c:strCache>
            </c:strRef>
          </c:cat>
          <c:val>
            <c:numRef>
              <c:f>Sheet1!$D$3:$D$32</c:f>
              <c:numCache>
                <c:formatCode>General</c:formatCode>
                <c:ptCount val="30"/>
                <c:pt idx="0">
                  <c:v>179.79</c:v>
                </c:pt>
                <c:pt idx="1">
                  <c:v>41.86</c:v>
                </c:pt>
                <c:pt idx="2">
                  <c:v>99.85</c:v>
                </c:pt>
                <c:pt idx="3">
                  <c:v>10.11</c:v>
                </c:pt>
                <c:pt idx="4">
                  <c:v>137.68</c:v>
                </c:pt>
                <c:pt idx="5">
                  <c:v>40.200000000000003</c:v>
                </c:pt>
                <c:pt idx="6">
                  <c:v>44.54</c:v>
                </c:pt>
                <c:pt idx="7">
                  <c:v>106.1</c:v>
                </c:pt>
                <c:pt idx="8">
                  <c:v>13.66</c:v>
                </c:pt>
                <c:pt idx="9">
                  <c:v>0.33</c:v>
                </c:pt>
                <c:pt idx="10">
                  <c:v>0.32</c:v>
                </c:pt>
                <c:pt idx="11">
                  <c:v>0.41</c:v>
                </c:pt>
                <c:pt idx="12">
                  <c:v>0.2</c:v>
                </c:pt>
                <c:pt idx="13">
                  <c:v>0.27</c:v>
                </c:pt>
                <c:pt idx="14">
                  <c:v>0.2</c:v>
                </c:pt>
                <c:pt idx="15">
                  <c:v>0.24</c:v>
                </c:pt>
                <c:pt idx="16">
                  <c:v>0.25</c:v>
                </c:pt>
                <c:pt idx="17">
                  <c:v>0.53</c:v>
                </c:pt>
                <c:pt idx="18">
                  <c:v>0.6</c:v>
                </c:pt>
                <c:pt idx="19">
                  <c:v>56.35</c:v>
                </c:pt>
                <c:pt idx="20">
                  <c:v>8.58</c:v>
                </c:pt>
                <c:pt idx="21">
                  <c:v>0.38</c:v>
                </c:pt>
                <c:pt idx="22">
                  <c:v>0.27</c:v>
                </c:pt>
                <c:pt idx="23">
                  <c:v>0.22</c:v>
                </c:pt>
                <c:pt idx="24">
                  <c:v>0.2</c:v>
                </c:pt>
                <c:pt idx="25">
                  <c:v>0.21</c:v>
                </c:pt>
                <c:pt idx="26">
                  <c:v>0.2</c:v>
                </c:pt>
                <c:pt idx="27">
                  <c:v>0.61</c:v>
                </c:pt>
                <c:pt idx="28">
                  <c:v>3.92</c:v>
                </c:pt>
                <c:pt idx="29">
                  <c:v>24.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BB3-4D01-A5EA-3FD8EE11EC1B}"/>
            </c:ext>
          </c:extLst>
        </c:ser>
        <c:ser>
          <c:idx val="2"/>
          <c:order val="2"/>
          <c:tx>
            <c:strRef>
              <c:f>Sheet1!$E$2</c:f>
              <c:strCache>
                <c:ptCount val="1"/>
                <c:pt idx="0">
                  <c:v>ESR （mm/h）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Sheet1!$B$3:$B$32</c:f>
              <c:strCache>
                <c:ptCount val="30"/>
                <c:pt idx="0">
                  <c:v>120week</c:v>
                </c:pt>
                <c:pt idx="1">
                  <c:v>100week</c:v>
                </c:pt>
                <c:pt idx="2">
                  <c:v>80week</c:v>
                </c:pt>
                <c:pt idx="3">
                  <c:v>60week</c:v>
                </c:pt>
                <c:pt idx="4">
                  <c:v>40week</c:v>
                </c:pt>
                <c:pt idx="5">
                  <c:v>20week</c:v>
                </c:pt>
                <c:pt idx="6">
                  <c:v>10week</c:v>
                </c:pt>
                <c:pt idx="7">
                  <c:v>0week</c:v>
                </c:pt>
                <c:pt idx="8">
                  <c:v>1week</c:v>
                </c:pt>
                <c:pt idx="9">
                  <c:v>3week</c:v>
                </c:pt>
                <c:pt idx="10">
                  <c:v>6week</c:v>
                </c:pt>
                <c:pt idx="11">
                  <c:v>9week</c:v>
                </c:pt>
                <c:pt idx="12">
                  <c:v>12week</c:v>
                </c:pt>
                <c:pt idx="13">
                  <c:v>15week</c:v>
                </c:pt>
                <c:pt idx="14">
                  <c:v>18week</c:v>
                </c:pt>
                <c:pt idx="15">
                  <c:v>21week</c:v>
                </c:pt>
                <c:pt idx="16">
                  <c:v>24week</c:v>
                </c:pt>
                <c:pt idx="17">
                  <c:v>27week</c:v>
                </c:pt>
                <c:pt idx="18">
                  <c:v>30week</c:v>
                </c:pt>
                <c:pt idx="19">
                  <c:v>33week</c:v>
                </c:pt>
                <c:pt idx="20">
                  <c:v>34week</c:v>
                </c:pt>
                <c:pt idx="21">
                  <c:v>39week</c:v>
                </c:pt>
                <c:pt idx="22">
                  <c:v>42week</c:v>
                </c:pt>
                <c:pt idx="23">
                  <c:v>45week</c:v>
                </c:pt>
                <c:pt idx="24">
                  <c:v>48week</c:v>
                </c:pt>
                <c:pt idx="25">
                  <c:v>51week</c:v>
                </c:pt>
                <c:pt idx="26">
                  <c:v>54week</c:v>
                </c:pt>
                <c:pt idx="27">
                  <c:v>57week</c:v>
                </c:pt>
                <c:pt idx="28">
                  <c:v>60week</c:v>
                </c:pt>
                <c:pt idx="29">
                  <c:v>63week</c:v>
                </c:pt>
              </c:strCache>
            </c:strRef>
          </c:cat>
          <c:val>
            <c:numRef>
              <c:f>Sheet1!$E$3:$E$32</c:f>
              <c:numCache>
                <c:formatCode>General</c:formatCode>
                <c:ptCount val="30"/>
                <c:pt idx="0">
                  <c:v>48</c:v>
                </c:pt>
                <c:pt idx="1">
                  <c:v>48</c:v>
                </c:pt>
                <c:pt idx="2">
                  <c:v>47</c:v>
                </c:pt>
                <c:pt idx="3">
                  <c:v>36</c:v>
                </c:pt>
                <c:pt idx="4">
                  <c:v>23</c:v>
                </c:pt>
                <c:pt idx="5">
                  <c:v>40</c:v>
                </c:pt>
                <c:pt idx="6">
                  <c:v>17</c:v>
                </c:pt>
                <c:pt idx="7">
                  <c:v>85</c:v>
                </c:pt>
                <c:pt idx="8">
                  <c:v>62</c:v>
                </c:pt>
                <c:pt idx="9">
                  <c:v>7</c:v>
                </c:pt>
                <c:pt idx="10">
                  <c:v>8</c:v>
                </c:pt>
                <c:pt idx="11">
                  <c:v>2</c:v>
                </c:pt>
                <c:pt idx="12">
                  <c:v>2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3</c:v>
                </c:pt>
                <c:pt idx="17">
                  <c:v>2</c:v>
                </c:pt>
                <c:pt idx="18">
                  <c:v>2</c:v>
                </c:pt>
                <c:pt idx="19">
                  <c:v>26</c:v>
                </c:pt>
                <c:pt idx="20">
                  <c:v>2</c:v>
                </c:pt>
                <c:pt idx="21">
                  <c:v>3</c:v>
                </c:pt>
                <c:pt idx="22">
                  <c:v>2</c:v>
                </c:pt>
                <c:pt idx="23">
                  <c:v>2</c:v>
                </c:pt>
                <c:pt idx="24">
                  <c:v>2</c:v>
                </c:pt>
                <c:pt idx="25">
                  <c:v>6</c:v>
                </c:pt>
                <c:pt idx="26">
                  <c:v>2</c:v>
                </c:pt>
                <c:pt idx="27">
                  <c:v>10</c:v>
                </c:pt>
                <c:pt idx="28">
                  <c:v>9</c:v>
                </c:pt>
                <c:pt idx="29">
                  <c:v>1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BB3-4D01-A5EA-3FD8EE11EC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5284064"/>
        <c:axId val="1935292384"/>
      </c:lineChart>
      <c:catAx>
        <c:axId val="193528406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935292384"/>
        <c:crosses val="autoZero"/>
        <c:auto val="1"/>
        <c:lblAlgn val="ctr"/>
        <c:lblOffset val="100"/>
        <c:noMultiLvlLbl val="0"/>
      </c:catAx>
      <c:valAx>
        <c:axId val="1935292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93528406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3883605331456472"/>
          <c:y val="8.5433732548137367E-2"/>
          <c:w val="0.2400186219739292"/>
          <c:h val="0.208683914510686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1443535243875588E-2"/>
          <c:y val="4.6550093352373777E-2"/>
          <c:w val="0.91949259906666447"/>
          <c:h val="0.75346720528139488"/>
        </c:manualLayout>
      </c:layout>
      <c:lineChart>
        <c:grouping val="standard"/>
        <c:varyColors val="0"/>
        <c:ser>
          <c:idx val="0"/>
          <c:order val="0"/>
          <c:tx>
            <c:strRef>
              <c:f>Sheet1!$G$2</c:f>
              <c:strCache>
                <c:ptCount val="1"/>
                <c:pt idx="0">
                  <c:v>IL-6（pg/ml）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Sheet1!$F$3:$F$32</c:f>
              <c:strCache>
                <c:ptCount val="30"/>
                <c:pt idx="0">
                  <c:v>120weeks</c:v>
                </c:pt>
                <c:pt idx="1">
                  <c:v>100weeks</c:v>
                </c:pt>
                <c:pt idx="2">
                  <c:v>80weeks</c:v>
                </c:pt>
                <c:pt idx="3">
                  <c:v>60weeks</c:v>
                </c:pt>
                <c:pt idx="4">
                  <c:v>40weeks</c:v>
                </c:pt>
                <c:pt idx="5">
                  <c:v>20weeks</c:v>
                </c:pt>
                <c:pt idx="6">
                  <c:v>10weeks</c:v>
                </c:pt>
                <c:pt idx="7">
                  <c:v>0week</c:v>
                </c:pt>
                <c:pt idx="8">
                  <c:v>1week</c:v>
                </c:pt>
                <c:pt idx="9">
                  <c:v>3weeks</c:v>
                </c:pt>
                <c:pt idx="10">
                  <c:v>6weeks</c:v>
                </c:pt>
                <c:pt idx="11">
                  <c:v>9weeks</c:v>
                </c:pt>
                <c:pt idx="12">
                  <c:v>12weeks</c:v>
                </c:pt>
                <c:pt idx="13">
                  <c:v>15weeks</c:v>
                </c:pt>
                <c:pt idx="14">
                  <c:v>18weeks</c:v>
                </c:pt>
                <c:pt idx="15">
                  <c:v>21weeks</c:v>
                </c:pt>
                <c:pt idx="16">
                  <c:v>24weeks</c:v>
                </c:pt>
                <c:pt idx="17">
                  <c:v>27weeks</c:v>
                </c:pt>
                <c:pt idx="18">
                  <c:v>30weeks</c:v>
                </c:pt>
                <c:pt idx="19">
                  <c:v>33weeks</c:v>
                </c:pt>
                <c:pt idx="20">
                  <c:v>34weeks</c:v>
                </c:pt>
                <c:pt idx="21">
                  <c:v>39weeks</c:v>
                </c:pt>
                <c:pt idx="22">
                  <c:v>42weeks</c:v>
                </c:pt>
                <c:pt idx="23">
                  <c:v>45weeks</c:v>
                </c:pt>
                <c:pt idx="24">
                  <c:v>48weeks</c:v>
                </c:pt>
                <c:pt idx="25">
                  <c:v>51weeks</c:v>
                </c:pt>
                <c:pt idx="26">
                  <c:v>54weeks</c:v>
                </c:pt>
                <c:pt idx="27">
                  <c:v>57weeks</c:v>
                </c:pt>
                <c:pt idx="28">
                  <c:v>60weeks</c:v>
                </c:pt>
                <c:pt idx="29">
                  <c:v>63weeks</c:v>
                </c:pt>
              </c:strCache>
            </c:strRef>
          </c:cat>
          <c:val>
            <c:numRef>
              <c:f>Sheet1!$G$3:$G$32</c:f>
              <c:numCache>
                <c:formatCode>General</c:formatCode>
                <c:ptCount val="30"/>
                <c:pt idx="0">
                  <c:v>60.7</c:v>
                </c:pt>
                <c:pt idx="1">
                  <c:v>55.4</c:v>
                </c:pt>
                <c:pt idx="2">
                  <c:v>62.3</c:v>
                </c:pt>
                <c:pt idx="3">
                  <c:v>38</c:v>
                </c:pt>
                <c:pt idx="4">
                  <c:v>45</c:v>
                </c:pt>
                <c:pt idx="5">
                  <c:v>13.1</c:v>
                </c:pt>
                <c:pt idx="6">
                  <c:v>11.6</c:v>
                </c:pt>
                <c:pt idx="7">
                  <c:v>207.1</c:v>
                </c:pt>
                <c:pt idx="8">
                  <c:v>101</c:v>
                </c:pt>
                <c:pt idx="9">
                  <c:v>77.099999999999994</c:v>
                </c:pt>
                <c:pt idx="10">
                  <c:v>110.3</c:v>
                </c:pt>
                <c:pt idx="11">
                  <c:v>277.2</c:v>
                </c:pt>
                <c:pt idx="12">
                  <c:v>174.5</c:v>
                </c:pt>
                <c:pt idx="13">
                  <c:v>452.4</c:v>
                </c:pt>
                <c:pt idx="14">
                  <c:v>126.5</c:v>
                </c:pt>
                <c:pt idx="15">
                  <c:v>181.8</c:v>
                </c:pt>
                <c:pt idx="16">
                  <c:v>240.7</c:v>
                </c:pt>
                <c:pt idx="17">
                  <c:v>178</c:v>
                </c:pt>
                <c:pt idx="18">
                  <c:v>36.799999999999997</c:v>
                </c:pt>
                <c:pt idx="19">
                  <c:v>11.5</c:v>
                </c:pt>
                <c:pt idx="20">
                  <c:v>45</c:v>
                </c:pt>
                <c:pt idx="21">
                  <c:v>86.3</c:v>
                </c:pt>
                <c:pt idx="22">
                  <c:v>71.400000000000006</c:v>
                </c:pt>
                <c:pt idx="23">
                  <c:v>128.5</c:v>
                </c:pt>
                <c:pt idx="24">
                  <c:v>500</c:v>
                </c:pt>
                <c:pt idx="25">
                  <c:v>77.599999999999994</c:v>
                </c:pt>
                <c:pt idx="26">
                  <c:v>67.900000000000006</c:v>
                </c:pt>
                <c:pt idx="27">
                  <c:v>807.2</c:v>
                </c:pt>
                <c:pt idx="28">
                  <c:v>302.10000000000002</c:v>
                </c:pt>
                <c:pt idx="29">
                  <c:v>183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45F-4E23-BCB0-456B3AB9EFDA}"/>
            </c:ext>
          </c:extLst>
        </c:ser>
        <c:ser>
          <c:idx val="1"/>
          <c:order val="1"/>
          <c:tx>
            <c:strRef>
              <c:f>Sheet1!$H$2</c:f>
              <c:strCache>
                <c:ptCount val="1"/>
                <c:pt idx="0">
                  <c:v>TNF-α（pg/ml）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Sheet1!$F$3:$F$32</c:f>
              <c:strCache>
                <c:ptCount val="30"/>
                <c:pt idx="0">
                  <c:v>120weeks</c:v>
                </c:pt>
                <c:pt idx="1">
                  <c:v>100weeks</c:v>
                </c:pt>
                <c:pt idx="2">
                  <c:v>80weeks</c:v>
                </c:pt>
                <c:pt idx="3">
                  <c:v>60weeks</c:v>
                </c:pt>
                <c:pt idx="4">
                  <c:v>40weeks</c:v>
                </c:pt>
                <c:pt idx="5">
                  <c:v>20weeks</c:v>
                </c:pt>
                <c:pt idx="6">
                  <c:v>10weeks</c:v>
                </c:pt>
                <c:pt idx="7">
                  <c:v>0week</c:v>
                </c:pt>
                <c:pt idx="8">
                  <c:v>1week</c:v>
                </c:pt>
                <c:pt idx="9">
                  <c:v>3weeks</c:v>
                </c:pt>
                <c:pt idx="10">
                  <c:v>6weeks</c:v>
                </c:pt>
                <c:pt idx="11">
                  <c:v>9weeks</c:v>
                </c:pt>
                <c:pt idx="12">
                  <c:v>12weeks</c:v>
                </c:pt>
                <c:pt idx="13">
                  <c:v>15weeks</c:v>
                </c:pt>
                <c:pt idx="14">
                  <c:v>18weeks</c:v>
                </c:pt>
                <c:pt idx="15">
                  <c:v>21weeks</c:v>
                </c:pt>
                <c:pt idx="16">
                  <c:v>24weeks</c:v>
                </c:pt>
                <c:pt idx="17">
                  <c:v>27weeks</c:v>
                </c:pt>
                <c:pt idx="18">
                  <c:v>30weeks</c:v>
                </c:pt>
                <c:pt idx="19">
                  <c:v>33weeks</c:v>
                </c:pt>
                <c:pt idx="20">
                  <c:v>34weeks</c:v>
                </c:pt>
                <c:pt idx="21">
                  <c:v>39weeks</c:v>
                </c:pt>
                <c:pt idx="22">
                  <c:v>42weeks</c:v>
                </c:pt>
                <c:pt idx="23">
                  <c:v>45weeks</c:v>
                </c:pt>
                <c:pt idx="24">
                  <c:v>48weeks</c:v>
                </c:pt>
                <c:pt idx="25">
                  <c:v>51weeks</c:v>
                </c:pt>
                <c:pt idx="26">
                  <c:v>54weeks</c:v>
                </c:pt>
                <c:pt idx="27">
                  <c:v>57weeks</c:v>
                </c:pt>
                <c:pt idx="28">
                  <c:v>60weeks</c:v>
                </c:pt>
                <c:pt idx="29">
                  <c:v>63weeks</c:v>
                </c:pt>
              </c:strCache>
            </c:strRef>
          </c:cat>
          <c:val>
            <c:numRef>
              <c:f>Sheet1!$H$3:$H$32</c:f>
              <c:numCache>
                <c:formatCode>General</c:formatCode>
                <c:ptCount val="30"/>
                <c:pt idx="0">
                  <c:v>1</c:v>
                </c:pt>
                <c:pt idx="1">
                  <c:v>4.3</c:v>
                </c:pt>
                <c:pt idx="2">
                  <c:v>5.5</c:v>
                </c:pt>
                <c:pt idx="3">
                  <c:v>5.9</c:v>
                </c:pt>
                <c:pt idx="4">
                  <c:v>3.9</c:v>
                </c:pt>
                <c:pt idx="5">
                  <c:v>4.4000000000000004</c:v>
                </c:pt>
                <c:pt idx="6">
                  <c:v>1.3</c:v>
                </c:pt>
                <c:pt idx="7">
                  <c:v>2.8</c:v>
                </c:pt>
                <c:pt idx="8">
                  <c:v>4.3</c:v>
                </c:pt>
                <c:pt idx="9">
                  <c:v>1.8</c:v>
                </c:pt>
                <c:pt idx="10">
                  <c:v>1.4</c:v>
                </c:pt>
                <c:pt idx="11">
                  <c:v>1</c:v>
                </c:pt>
                <c:pt idx="12">
                  <c:v>1.5</c:v>
                </c:pt>
                <c:pt idx="13">
                  <c:v>1</c:v>
                </c:pt>
                <c:pt idx="14">
                  <c:v>1.6</c:v>
                </c:pt>
                <c:pt idx="15">
                  <c:v>1.5</c:v>
                </c:pt>
                <c:pt idx="16">
                  <c:v>1.4</c:v>
                </c:pt>
                <c:pt idx="17">
                  <c:v>1</c:v>
                </c:pt>
                <c:pt idx="18">
                  <c:v>1</c:v>
                </c:pt>
                <c:pt idx="19">
                  <c:v>1.5</c:v>
                </c:pt>
                <c:pt idx="20">
                  <c:v>3.2</c:v>
                </c:pt>
                <c:pt idx="21">
                  <c:v>1.3</c:v>
                </c:pt>
                <c:pt idx="22">
                  <c:v>1</c:v>
                </c:pt>
                <c:pt idx="23">
                  <c:v>3</c:v>
                </c:pt>
                <c:pt idx="24">
                  <c:v>5.8</c:v>
                </c:pt>
                <c:pt idx="25">
                  <c:v>1</c:v>
                </c:pt>
                <c:pt idx="26">
                  <c:v>1.2</c:v>
                </c:pt>
                <c:pt idx="27">
                  <c:v>2.9</c:v>
                </c:pt>
                <c:pt idx="28">
                  <c:v>4.5999999999999996</c:v>
                </c:pt>
                <c:pt idx="29">
                  <c:v>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45F-4E23-BCB0-456B3AB9EF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4770927"/>
        <c:axId val="614777167"/>
      </c:lineChart>
      <c:catAx>
        <c:axId val="6147709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614777167"/>
        <c:crosses val="autoZero"/>
        <c:auto val="1"/>
        <c:lblAlgn val="ctr"/>
        <c:lblOffset val="100"/>
        <c:noMultiLvlLbl val="0"/>
      </c:catAx>
      <c:valAx>
        <c:axId val="614777167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614770927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8334142505696893"/>
          <c:y val="6.9861110059517603E-2"/>
          <c:w val="0.17766368419148906"/>
          <c:h val="0.178179480026162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6329136835479611E-2"/>
          <c:y val="0.17661413520908431"/>
          <c:w val="0.93035538558560771"/>
          <c:h val="0.79786373471179328"/>
        </c:manualLayout>
      </c:layout>
      <c:lineChart>
        <c:grouping val="standar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WBC（x10^9/L）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Sheet1!$C$3:$C$24</c:f>
              <c:numCache>
                <c:formatCode>General</c:formatCode>
                <c:ptCount val="22"/>
                <c:pt idx="0">
                  <c:v>23.34</c:v>
                </c:pt>
                <c:pt idx="1">
                  <c:v>9</c:v>
                </c:pt>
                <c:pt idx="2">
                  <c:v>11.95</c:v>
                </c:pt>
                <c:pt idx="3">
                  <c:v>19.309999999999999</c:v>
                </c:pt>
                <c:pt idx="4">
                  <c:v>27.81</c:v>
                </c:pt>
                <c:pt idx="5">
                  <c:v>32.39</c:v>
                </c:pt>
                <c:pt idx="6">
                  <c:v>14.99</c:v>
                </c:pt>
                <c:pt idx="7">
                  <c:v>20.94</c:v>
                </c:pt>
                <c:pt idx="8">
                  <c:v>25.51</c:v>
                </c:pt>
                <c:pt idx="9">
                  <c:v>9.68</c:v>
                </c:pt>
                <c:pt idx="10">
                  <c:v>11.56</c:v>
                </c:pt>
                <c:pt idx="11">
                  <c:v>28.32</c:v>
                </c:pt>
                <c:pt idx="12">
                  <c:v>18.77</c:v>
                </c:pt>
                <c:pt idx="13">
                  <c:v>16.37</c:v>
                </c:pt>
                <c:pt idx="14">
                  <c:v>5.95</c:v>
                </c:pt>
                <c:pt idx="15">
                  <c:v>4.79</c:v>
                </c:pt>
                <c:pt idx="16">
                  <c:v>5.68</c:v>
                </c:pt>
                <c:pt idx="17">
                  <c:v>6.6</c:v>
                </c:pt>
                <c:pt idx="18">
                  <c:v>7.66</c:v>
                </c:pt>
                <c:pt idx="19">
                  <c:v>6.55</c:v>
                </c:pt>
                <c:pt idx="20">
                  <c:v>11.1</c:v>
                </c:pt>
                <c:pt idx="21">
                  <c:v>5.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830-4E51-9731-1E067949528B}"/>
            </c:ext>
          </c:extLst>
        </c:ser>
        <c:ser>
          <c:idx val="1"/>
          <c:order val="1"/>
          <c:tx>
            <c:strRef>
              <c:f>Sheet1!$D$2</c:f>
              <c:strCache>
                <c:ptCount val="1"/>
                <c:pt idx="0">
                  <c:v>CRP（mg/L）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val>
            <c:numRef>
              <c:f>Sheet1!$D$3:$D$24</c:f>
              <c:numCache>
                <c:formatCode>General</c:formatCode>
                <c:ptCount val="22"/>
                <c:pt idx="0">
                  <c:v>183.57</c:v>
                </c:pt>
                <c:pt idx="1">
                  <c:v>51.92</c:v>
                </c:pt>
                <c:pt idx="2">
                  <c:v>123.32</c:v>
                </c:pt>
                <c:pt idx="3">
                  <c:v>36.869999999999997</c:v>
                </c:pt>
                <c:pt idx="4">
                  <c:v>65.11</c:v>
                </c:pt>
                <c:pt idx="5">
                  <c:v>59.46</c:v>
                </c:pt>
                <c:pt idx="6">
                  <c:v>17.260000000000002</c:v>
                </c:pt>
                <c:pt idx="7">
                  <c:v>44.66</c:v>
                </c:pt>
                <c:pt idx="8">
                  <c:v>13.02</c:v>
                </c:pt>
                <c:pt idx="9">
                  <c:v>56.54</c:v>
                </c:pt>
                <c:pt idx="10">
                  <c:v>26.08</c:v>
                </c:pt>
                <c:pt idx="11">
                  <c:v>89.72</c:v>
                </c:pt>
                <c:pt idx="12">
                  <c:v>18.920000000000002</c:v>
                </c:pt>
                <c:pt idx="13">
                  <c:v>23.08</c:v>
                </c:pt>
                <c:pt idx="14">
                  <c:v>0.2</c:v>
                </c:pt>
                <c:pt idx="15">
                  <c:v>0.2</c:v>
                </c:pt>
                <c:pt idx="16">
                  <c:v>0.2</c:v>
                </c:pt>
                <c:pt idx="17">
                  <c:v>0.31</c:v>
                </c:pt>
                <c:pt idx="18">
                  <c:v>0.2</c:v>
                </c:pt>
                <c:pt idx="19">
                  <c:v>3.37</c:v>
                </c:pt>
                <c:pt idx="20">
                  <c:v>18.649999999999999</c:v>
                </c:pt>
                <c:pt idx="21">
                  <c:v>0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30-4E51-9731-1E067949528B}"/>
            </c:ext>
          </c:extLst>
        </c:ser>
        <c:ser>
          <c:idx val="2"/>
          <c:order val="2"/>
          <c:tx>
            <c:strRef>
              <c:f>Sheet1!$E$2</c:f>
              <c:strCache>
                <c:ptCount val="1"/>
                <c:pt idx="0">
                  <c:v>ESR （mm/h）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val>
            <c:numRef>
              <c:f>Sheet1!$E$3:$E$24</c:f>
              <c:numCache>
                <c:formatCode>General</c:formatCode>
                <c:ptCount val="22"/>
                <c:pt idx="0">
                  <c:v>140</c:v>
                </c:pt>
                <c:pt idx="1">
                  <c:v>108</c:v>
                </c:pt>
                <c:pt idx="2">
                  <c:v>64</c:v>
                </c:pt>
                <c:pt idx="3">
                  <c:v>105</c:v>
                </c:pt>
                <c:pt idx="4">
                  <c:v>83</c:v>
                </c:pt>
                <c:pt idx="5">
                  <c:v>103</c:v>
                </c:pt>
                <c:pt idx="6">
                  <c:v>116</c:v>
                </c:pt>
                <c:pt idx="7">
                  <c:v>46</c:v>
                </c:pt>
                <c:pt idx="8">
                  <c:v>93</c:v>
                </c:pt>
                <c:pt idx="9">
                  <c:v>34</c:v>
                </c:pt>
                <c:pt idx="10">
                  <c:v>40</c:v>
                </c:pt>
                <c:pt idx="11">
                  <c:v>85</c:v>
                </c:pt>
                <c:pt idx="12">
                  <c:v>78</c:v>
                </c:pt>
                <c:pt idx="13">
                  <c:v>58</c:v>
                </c:pt>
                <c:pt idx="14">
                  <c:v>8</c:v>
                </c:pt>
                <c:pt idx="15">
                  <c:v>2</c:v>
                </c:pt>
                <c:pt idx="16">
                  <c:v>5</c:v>
                </c:pt>
                <c:pt idx="17">
                  <c:v>9</c:v>
                </c:pt>
                <c:pt idx="18">
                  <c:v>5</c:v>
                </c:pt>
                <c:pt idx="19">
                  <c:v>8</c:v>
                </c:pt>
                <c:pt idx="20">
                  <c:v>20</c:v>
                </c:pt>
                <c:pt idx="21">
                  <c:v>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830-4E51-9731-1E06794952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08467871"/>
        <c:axId val="1408468287"/>
      </c:lineChart>
      <c:catAx>
        <c:axId val="1408467871"/>
        <c:scaling>
          <c:orientation val="minMax"/>
        </c:scaling>
        <c:delete val="1"/>
        <c:axPos val="b"/>
        <c:majorTickMark val="none"/>
        <c:minorTickMark val="none"/>
        <c:tickLblPos val="nextTo"/>
        <c:crossAx val="1408468287"/>
        <c:crosses val="autoZero"/>
        <c:auto val="1"/>
        <c:lblAlgn val="ctr"/>
        <c:lblOffset val="100"/>
        <c:noMultiLvlLbl val="0"/>
      </c:catAx>
      <c:valAx>
        <c:axId val="1408468287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408467871"/>
        <c:crosses val="autoZero"/>
        <c:crossBetween val="between"/>
      </c:valAx>
      <c:spPr>
        <a:noFill/>
        <a:ln>
          <a:solidFill>
            <a:schemeClr val="dk1"/>
          </a:solidFill>
        </a:ln>
        <a:effectLst/>
      </c:spPr>
    </c:plotArea>
    <c:legend>
      <c:legendPos val="b"/>
      <c:layout>
        <c:manualLayout>
          <c:xMode val="edge"/>
          <c:yMode val="edge"/>
          <c:x val="0.71541018798217326"/>
          <c:y val="0.27444958720266138"/>
          <c:w val="0.25819899225881726"/>
          <c:h val="0.279079542140565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7067329698896529E-2"/>
          <c:y val="2.6933249693134969E-2"/>
          <c:w val="0.95117467613416751"/>
          <c:h val="0.58545071637190793"/>
        </c:manualLayout>
      </c:layout>
      <c:lineChart>
        <c:grouping val="standard"/>
        <c:varyColors val="0"/>
        <c:ser>
          <c:idx val="0"/>
          <c:order val="0"/>
          <c:tx>
            <c:strRef>
              <c:f>Sheet1!$J$2</c:f>
              <c:strCache>
                <c:ptCount val="1"/>
                <c:pt idx="0">
                  <c:v>IL-6（pg/ml）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Sheet1!$I$3:$I$24</c:f>
              <c:strCache>
                <c:ptCount val="22"/>
                <c:pt idx="0">
                  <c:v>120weeks</c:v>
                </c:pt>
                <c:pt idx="1">
                  <c:v>110weeks</c:v>
                </c:pt>
                <c:pt idx="2">
                  <c:v>100weeks</c:v>
                </c:pt>
                <c:pt idx="3">
                  <c:v>90weeks</c:v>
                </c:pt>
                <c:pt idx="4">
                  <c:v>80weeks</c:v>
                </c:pt>
                <c:pt idx="5">
                  <c:v>70weeks</c:v>
                </c:pt>
                <c:pt idx="6">
                  <c:v>60weeks</c:v>
                </c:pt>
                <c:pt idx="7">
                  <c:v>50weeks</c:v>
                </c:pt>
                <c:pt idx="8">
                  <c:v>40weeks</c:v>
                </c:pt>
                <c:pt idx="9">
                  <c:v>30weeks</c:v>
                </c:pt>
                <c:pt idx="10">
                  <c:v>20weeks</c:v>
                </c:pt>
                <c:pt idx="11">
                  <c:v>10weeks</c:v>
                </c:pt>
                <c:pt idx="12">
                  <c:v>2weeks</c:v>
                </c:pt>
                <c:pt idx="13">
                  <c:v>0week</c:v>
                </c:pt>
                <c:pt idx="14">
                  <c:v>3weeks</c:v>
                </c:pt>
                <c:pt idx="15">
                  <c:v>6weeks</c:v>
                </c:pt>
                <c:pt idx="16">
                  <c:v>9weeks</c:v>
                </c:pt>
                <c:pt idx="17">
                  <c:v>12weeks</c:v>
                </c:pt>
                <c:pt idx="18">
                  <c:v>15weeks</c:v>
                </c:pt>
                <c:pt idx="19">
                  <c:v>18weeks</c:v>
                </c:pt>
                <c:pt idx="20">
                  <c:v>21weeks</c:v>
                </c:pt>
                <c:pt idx="21">
                  <c:v>24weeks</c:v>
                </c:pt>
              </c:strCache>
            </c:strRef>
          </c:cat>
          <c:val>
            <c:numRef>
              <c:f>Sheet1!$J$3:$J$24</c:f>
              <c:numCache>
                <c:formatCode>General</c:formatCode>
                <c:ptCount val="22"/>
                <c:pt idx="0">
                  <c:v>232.1</c:v>
                </c:pt>
                <c:pt idx="1">
                  <c:v>16.8</c:v>
                </c:pt>
                <c:pt idx="2">
                  <c:v>47.9</c:v>
                </c:pt>
                <c:pt idx="3">
                  <c:v>10.6</c:v>
                </c:pt>
                <c:pt idx="4">
                  <c:v>40.1</c:v>
                </c:pt>
                <c:pt idx="5">
                  <c:v>312</c:v>
                </c:pt>
                <c:pt idx="6">
                  <c:v>22.2</c:v>
                </c:pt>
                <c:pt idx="7">
                  <c:v>34.299999999999997</c:v>
                </c:pt>
                <c:pt idx="8">
                  <c:v>23.5</c:v>
                </c:pt>
                <c:pt idx="9">
                  <c:v>45</c:v>
                </c:pt>
                <c:pt idx="10">
                  <c:v>24.2</c:v>
                </c:pt>
                <c:pt idx="11">
                  <c:v>62.2</c:v>
                </c:pt>
                <c:pt idx="12">
                  <c:v>6.8</c:v>
                </c:pt>
                <c:pt idx="13">
                  <c:v>6.8</c:v>
                </c:pt>
                <c:pt idx="14">
                  <c:v>18.7</c:v>
                </c:pt>
                <c:pt idx="15">
                  <c:v>63.7</c:v>
                </c:pt>
                <c:pt idx="16">
                  <c:v>23.5</c:v>
                </c:pt>
                <c:pt idx="17">
                  <c:v>4.5</c:v>
                </c:pt>
                <c:pt idx="18">
                  <c:v>11.2</c:v>
                </c:pt>
                <c:pt idx="19">
                  <c:v>20.100000000000001</c:v>
                </c:pt>
                <c:pt idx="20">
                  <c:v>21.1</c:v>
                </c:pt>
                <c:pt idx="21">
                  <c:v>2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38A-4C4D-B5AF-543E5725C31A}"/>
            </c:ext>
          </c:extLst>
        </c:ser>
        <c:ser>
          <c:idx val="1"/>
          <c:order val="1"/>
          <c:tx>
            <c:strRef>
              <c:f>Sheet1!$K$2</c:f>
              <c:strCache>
                <c:ptCount val="1"/>
                <c:pt idx="0">
                  <c:v>TNF-α（pg/ml）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Sheet1!$I$3:$I$24</c:f>
              <c:strCache>
                <c:ptCount val="22"/>
                <c:pt idx="0">
                  <c:v>120weeks</c:v>
                </c:pt>
                <c:pt idx="1">
                  <c:v>110weeks</c:v>
                </c:pt>
                <c:pt idx="2">
                  <c:v>100weeks</c:v>
                </c:pt>
                <c:pt idx="3">
                  <c:v>90weeks</c:v>
                </c:pt>
                <c:pt idx="4">
                  <c:v>80weeks</c:v>
                </c:pt>
                <c:pt idx="5">
                  <c:v>70weeks</c:v>
                </c:pt>
                <c:pt idx="6">
                  <c:v>60weeks</c:v>
                </c:pt>
                <c:pt idx="7">
                  <c:v>50weeks</c:v>
                </c:pt>
                <c:pt idx="8">
                  <c:v>40weeks</c:v>
                </c:pt>
                <c:pt idx="9">
                  <c:v>30weeks</c:v>
                </c:pt>
                <c:pt idx="10">
                  <c:v>20weeks</c:v>
                </c:pt>
                <c:pt idx="11">
                  <c:v>10weeks</c:v>
                </c:pt>
                <c:pt idx="12">
                  <c:v>2weeks</c:v>
                </c:pt>
                <c:pt idx="13">
                  <c:v>0week</c:v>
                </c:pt>
                <c:pt idx="14">
                  <c:v>3weeks</c:v>
                </c:pt>
                <c:pt idx="15">
                  <c:v>6weeks</c:v>
                </c:pt>
                <c:pt idx="16">
                  <c:v>9weeks</c:v>
                </c:pt>
                <c:pt idx="17">
                  <c:v>12weeks</c:v>
                </c:pt>
                <c:pt idx="18">
                  <c:v>15weeks</c:v>
                </c:pt>
                <c:pt idx="19">
                  <c:v>18weeks</c:v>
                </c:pt>
                <c:pt idx="20">
                  <c:v>21weeks</c:v>
                </c:pt>
                <c:pt idx="21">
                  <c:v>24weeks</c:v>
                </c:pt>
              </c:strCache>
            </c:strRef>
          </c:cat>
          <c:val>
            <c:numRef>
              <c:f>Sheet1!$K$3:$K$24</c:f>
              <c:numCache>
                <c:formatCode>General</c:formatCode>
                <c:ptCount val="22"/>
                <c:pt idx="0">
                  <c:v>234.1</c:v>
                </c:pt>
                <c:pt idx="1">
                  <c:v>157.5</c:v>
                </c:pt>
                <c:pt idx="2">
                  <c:v>162.19999999999999</c:v>
                </c:pt>
                <c:pt idx="3">
                  <c:v>202.2</c:v>
                </c:pt>
                <c:pt idx="4">
                  <c:v>7.8</c:v>
                </c:pt>
                <c:pt idx="5">
                  <c:v>534.6</c:v>
                </c:pt>
                <c:pt idx="6">
                  <c:v>218.9</c:v>
                </c:pt>
                <c:pt idx="7">
                  <c:v>122.8</c:v>
                </c:pt>
                <c:pt idx="8">
                  <c:v>38.6</c:v>
                </c:pt>
                <c:pt idx="9">
                  <c:v>185.4</c:v>
                </c:pt>
                <c:pt idx="10">
                  <c:v>127.5</c:v>
                </c:pt>
                <c:pt idx="11">
                  <c:v>206.6</c:v>
                </c:pt>
                <c:pt idx="12">
                  <c:v>157.1</c:v>
                </c:pt>
                <c:pt idx="13">
                  <c:v>157.1</c:v>
                </c:pt>
                <c:pt idx="14">
                  <c:v>4.7</c:v>
                </c:pt>
                <c:pt idx="15">
                  <c:v>1.7</c:v>
                </c:pt>
                <c:pt idx="16">
                  <c:v>2.2999999999999998</c:v>
                </c:pt>
                <c:pt idx="17">
                  <c:v>1.5</c:v>
                </c:pt>
                <c:pt idx="18">
                  <c:v>2.1</c:v>
                </c:pt>
                <c:pt idx="19">
                  <c:v>3.1</c:v>
                </c:pt>
                <c:pt idx="20">
                  <c:v>1.5</c:v>
                </c:pt>
                <c:pt idx="21">
                  <c:v>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38A-4C4D-B5AF-543E5725C3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08482431"/>
        <c:axId val="1408482847"/>
      </c:lineChart>
      <c:catAx>
        <c:axId val="14084824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408482847"/>
        <c:crosses val="autoZero"/>
        <c:auto val="1"/>
        <c:lblAlgn val="ctr"/>
        <c:lblOffset val="100"/>
        <c:noMultiLvlLbl val="0"/>
      </c:catAx>
      <c:valAx>
        <c:axId val="1408482847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408482431"/>
        <c:crosses val="autoZero"/>
        <c:crossBetween val="between"/>
      </c:valAx>
      <c:spPr>
        <a:noFill/>
        <a:ln>
          <a:solidFill>
            <a:schemeClr val="dk1"/>
          </a:solidFill>
        </a:ln>
        <a:effectLst/>
      </c:spPr>
    </c:plotArea>
    <c:legend>
      <c:legendPos val="b"/>
      <c:layout>
        <c:manualLayout>
          <c:xMode val="edge"/>
          <c:yMode val="edge"/>
          <c:x val="0.73450588018738583"/>
          <c:y val="0.12351882351941197"/>
          <c:w val="0.23843969611100366"/>
          <c:h val="0.2068324873826615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6949</cdr:x>
      <cdr:y>0.27765</cdr:y>
    </cdr:from>
    <cdr:to>
      <cdr:x>0.73073</cdr:x>
      <cdr:y>0.44273</cdr:y>
    </cdr:to>
    <cdr:sp macro="" textlink="">
      <cdr:nvSpPr>
        <cdr:cNvPr id="2" name="矩形 1">
          <a:extLst xmlns:a="http://schemas.openxmlformats.org/drawingml/2006/main">
            <a:ext uri="{FF2B5EF4-FFF2-40B4-BE49-F238E27FC236}">
              <a16:creationId xmlns:a16="http://schemas.microsoft.com/office/drawing/2014/main" id="{B0791A05-71D2-13F3-D202-26277A056D6E}"/>
            </a:ext>
          </a:extLst>
        </cdr:cNvPr>
        <cdr:cNvSpPr/>
      </cdr:nvSpPr>
      <cdr:spPr>
        <a:xfrm xmlns:a="http://schemas.openxmlformats.org/drawingml/2006/main">
          <a:off x="3224190" y="849292"/>
          <a:ext cx="3152194" cy="504959"/>
        </a:xfrm>
        <a:prstGeom xmlns:a="http://schemas.openxmlformats.org/drawingml/2006/main" prst="rect">
          <a:avLst/>
        </a:prstGeom>
      </cdr:spPr>
      <cdr:style>
        <a:lnRef xmlns:a="http://schemas.openxmlformats.org/drawingml/2006/main" idx="2">
          <a:schemeClr val="dk1"/>
        </a:lnRef>
        <a:fillRef xmlns:a="http://schemas.openxmlformats.org/drawingml/2006/main" idx="1">
          <a:schemeClr val="lt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zh-CN"/>
          </a:defPPr>
          <a:lvl1pPr marL="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zh-CN" sz="1200" b="1" dirty="0">
              <a:latin typeface="Arial" panose="020B0604020202020204" pitchFamily="34" charset="0"/>
              <a:cs typeface="Arial" panose="020B0604020202020204" pitchFamily="34" charset="0"/>
            </a:rPr>
            <a:t>First dose Tocilizumab 27-09-2021</a:t>
          </a:r>
          <a:endParaRPr lang="zh-CN" altLang="en-US" sz="12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3211</cdr:x>
      <cdr:y>0.5</cdr:y>
    </cdr:from>
    <cdr:to>
      <cdr:x>0.63211</cdr:x>
      <cdr:y>0.69365</cdr:y>
    </cdr:to>
    <cdr:cxnSp macro="">
      <cdr:nvCxnSpPr>
        <cdr:cNvPr id="4" name="直接箭头连接符 3">
          <a:extLst xmlns:a="http://schemas.openxmlformats.org/drawingml/2006/main">
            <a:ext uri="{FF2B5EF4-FFF2-40B4-BE49-F238E27FC236}">
              <a16:creationId xmlns:a16="http://schemas.microsoft.com/office/drawing/2014/main" id="{9C1863DA-63C2-2C7C-244B-C974610B9FC3}"/>
            </a:ext>
          </a:extLst>
        </cdr:cNvPr>
        <cdr:cNvCxnSpPr/>
      </cdr:nvCxnSpPr>
      <cdr:spPr>
        <a:xfrm xmlns:a="http://schemas.openxmlformats.org/drawingml/2006/main">
          <a:off x="5515757" y="1529443"/>
          <a:ext cx="0" cy="592356"/>
        </a:xfrm>
        <a:prstGeom xmlns:a="http://schemas.openxmlformats.org/drawingml/2006/main" prst="straightConnector1">
          <a:avLst/>
        </a:prstGeom>
        <a:ln xmlns:a="http://schemas.openxmlformats.org/drawingml/2006/main" w="28575"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4375</cdr:x>
      <cdr:y>0.5</cdr:y>
    </cdr:from>
    <cdr:to>
      <cdr:x>0.68363</cdr:x>
      <cdr:y>0.60356</cdr:y>
    </cdr:to>
    <cdr:sp macro="" textlink="">
      <cdr:nvSpPr>
        <cdr:cNvPr id="7" name="矩形 6">
          <a:extLst xmlns:a="http://schemas.openxmlformats.org/drawingml/2006/main">
            <a:ext uri="{FF2B5EF4-FFF2-40B4-BE49-F238E27FC236}">
              <a16:creationId xmlns:a16="http://schemas.microsoft.com/office/drawing/2014/main" id="{B4069823-383F-9510-E325-CB2C74D0AA41}"/>
            </a:ext>
          </a:extLst>
        </cdr:cNvPr>
        <cdr:cNvSpPr/>
      </cdr:nvSpPr>
      <cdr:spPr>
        <a:xfrm xmlns:a="http://schemas.openxmlformats.org/drawingml/2006/main" flipH="1">
          <a:off x="5617328" y="1529443"/>
          <a:ext cx="348042" cy="316775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dk1"/>
        </a:lnRef>
        <a:fillRef xmlns:a="http://schemas.openxmlformats.org/drawingml/2006/main" idx="1">
          <a:schemeClr val="lt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r>
            <a:rPr lang="en-US" altLang="zh-CN" sz="1600" b="1" dirty="0">
              <a:latin typeface="Arial" panose="020B0604020202020204" pitchFamily="34" charset="0"/>
              <a:cs typeface="Arial" panose="020B0604020202020204" pitchFamily="34" charset="0"/>
            </a:rPr>
            <a:t>B</a:t>
          </a:r>
          <a:endParaRPr lang="zh-CN" sz="16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2CE3D5-9843-4B1E-8922-7D516B1A4540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B13400-C8E2-4B30-BEE8-11F5C4AEB7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8335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B13400-C8E2-4B30-BEE8-11F5C4AEB7B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25192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39F7D6-C6C5-4161-BA7D-CB4F826FC2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4EE53B0-DDF6-97D8-1B00-6E08D547D2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52BCBB-3ED4-0505-A8A2-4DE17B425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3006C8-1C82-7630-029B-E5BC415FB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AF1BF0-1E0C-A3F8-F8DB-9E2066BC9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9189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B06909-3358-A114-A19E-8B7962CDA7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C2A41F2-84C5-93E5-2FE1-606A08798C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5A49A8-5190-B1E5-25A8-E4EFE7611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B2D69E-05A8-0709-02BE-22DEA2392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F1B6A4-8891-A233-D2EE-39279FB5F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4095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9C76B11-BC31-7B43-5BD2-9766C25214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FFC7920-E321-2487-23FE-487958EE76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DC5EF9-3E35-08D1-0724-4F8F02773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39C0B9-E54E-7218-10FB-49D3C0E7F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BAB6E2-A389-C6FF-952C-23684E8F6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164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2EF36E-5093-79DD-A975-7B5024948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0F2EFD-5E19-094A-E43F-2987A88988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7CD3F4-8F69-A401-AF42-8AF64A22F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966904D-4787-E096-CD20-9D894B0CB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7B737B-BFF9-3068-3885-F90E05F84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5063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226B8B-6577-10F5-FECB-8F428A75F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71AFC39-2A3C-6D10-12C3-08D76C1D4F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2AB49E-73C7-3BB2-BA50-573F05F88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FFA112-9A27-CD5B-9DD4-6E7311193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27F8213-4FC7-8EF0-1507-417E38E99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5275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402037-9EE8-EDC0-2179-2EA5EB8EFE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9BDFE4-217E-6A50-4ADF-C670E5B6C9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48FB57-AAE2-7C9D-37F2-580D6D2B93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8E0D8C-384E-E7D8-54F1-F345A8851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8D730D-7130-C6B5-39DB-375340B2A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92001BC-38F0-19BD-5A78-10FE494CC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8147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1BDBEE-8A37-2FC3-CA5D-F50CA2D8F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64E5D23-11C0-9483-7E4D-1590E8D045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9A5B210-0249-2A00-B398-B0A2A70F42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7E3175B-6526-AC09-870B-51868FC5B5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FFA1F90-469B-75AA-4FB7-36034792C1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01DCB50-ADAB-821C-BC9C-90F464D7A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803AA89-EFF5-5A99-C144-D78967BF0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6901AA0-82A8-B8FE-CD51-AB4AAC5B7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789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3CBC8A-59E7-62F0-E1DF-361BE9D5C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75B7855-6E82-CDE3-EDC3-86FDD2F3C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8C5338-DA88-783A-FAD5-BB7BCFC2B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1A4CF21-39C3-77FF-FFC5-EDFE24A73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7663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50DA87E-2939-872C-D489-4BE4A2C55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74BC778-2AA0-64EB-0EDB-878F871F6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B64FED2-267D-4995-BFD3-A64B4E321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647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75D967-2C88-A2D8-15C6-82C1FD0401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5C1F430-2C21-3759-809B-04056179DB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91E87B-8E53-7A06-6D54-DD4851CDF6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096D046-B74C-8275-8059-3E4A3F629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580A905-3B89-E887-45D5-257B4F193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A983FC-16FD-C887-1811-3F7E22DD0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0393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6D7E17-2191-F02E-C24E-49C073933B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F7C0292-BB84-9C16-79B5-3159DCDEE4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2E14EE-606F-7C09-EDCF-99C800D1BF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D2009D7-E927-1E3F-F4A8-CF79ADFB3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2D67658-C0E3-F617-F063-8E968677E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044B9AF-A2DA-3642-0820-987E31867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3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980C7B5-8285-24F9-5565-76994B0FC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92E00F-3E74-2F32-B404-3FA223F47C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9FB25A-40EB-FEED-F399-2E306F6754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EDA12-37AB-4CBC-BE5D-ECA46DA90667}" type="datetimeFigureOut">
              <a:rPr lang="zh-CN" altLang="en-US" smtClean="0"/>
              <a:t>2023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0AE9C3-A84B-BB90-2843-FA361D8179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B9CDA7-9EE0-7A51-2F3C-6D71444BDF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9752F-EF93-4EFE-9FFF-2353B0BE27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7338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2B346E-B3A8-A346-1768-070620C73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536787D-884C-2FBA-2C93-6DB7828875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altLang="zh-CN" dirty="0"/>
              <a:t>Patient 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617225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A5E14D3F-85CE-BC6A-D144-7C90B3B7FB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52222" r="50001" b="1"/>
          <a:stretch/>
        </p:blipFill>
        <p:spPr>
          <a:xfrm>
            <a:off x="8028711" y="96982"/>
            <a:ext cx="3666238" cy="3276600"/>
          </a:xfrm>
          <a:prstGeom prst="rect">
            <a:avLst/>
          </a:prstGeom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F2568C7C-FC63-40A4-E6AF-F6B4EEEAE822}"/>
              </a:ext>
            </a:extLst>
          </p:cNvPr>
          <p:cNvSpPr/>
          <p:nvPr/>
        </p:nvSpPr>
        <p:spPr>
          <a:xfrm>
            <a:off x="8028710" y="103908"/>
            <a:ext cx="367145" cy="346365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5CEE939B-96EE-BCCD-53A4-77610A288106}"/>
              </a:ext>
            </a:extLst>
          </p:cNvPr>
          <p:cNvGrpSpPr/>
          <p:nvPr/>
        </p:nvGrpSpPr>
        <p:grpSpPr>
          <a:xfrm>
            <a:off x="584498" y="166253"/>
            <a:ext cx="11023004" cy="6428509"/>
            <a:chOff x="497053" y="152400"/>
            <a:chExt cx="11023004" cy="6428509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3B635DF-0AA8-4099-91C5-E8D8FF0812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0000"/>
            <a:stretch/>
          </p:blipFill>
          <p:spPr>
            <a:xfrm>
              <a:off x="497053" y="152400"/>
              <a:ext cx="7332476" cy="3221182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C80DC4DD-93CC-7D23-0D9B-5A5CF7FED8E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109" y="3429000"/>
              <a:ext cx="3602182" cy="3151909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CBE01E82-28D1-63A3-89B3-B88A07AF19F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43400" y="3429000"/>
              <a:ext cx="3486129" cy="3151909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B8B37E8D-0D1E-156D-D3B5-4AECB78804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873" t="49596"/>
            <a:stretch/>
          </p:blipFill>
          <p:spPr>
            <a:xfrm>
              <a:off x="7917875" y="3401291"/>
              <a:ext cx="3602182" cy="3179618"/>
            </a:xfrm>
            <a:prstGeom prst="rect">
              <a:avLst/>
            </a:prstGeom>
          </p:spPr>
        </p:pic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E0D457DA-ABA5-75BD-E5AA-884A0156C715}"/>
                </a:ext>
              </a:extLst>
            </p:cNvPr>
            <p:cNvSpPr/>
            <p:nvPr/>
          </p:nvSpPr>
          <p:spPr>
            <a:xfrm>
              <a:off x="595745" y="3442854"/>
              <a:ext cx="367145" cy="34636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791DE9BF-2161-7C79-22AC-7EC07878C989}"/>
                </a:ext>
              </a:extLst>
            </p:cNvPr>
            <p:cNvSpPr/>
            <p:nvPr/>
          </p:nvSpPr>
          <p:spPr>
            <a:xfrm>
              <a:off x="4343400" y="3442854"/>
              <a:ext cx="367145" cy="34636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FD5587CE-DB2A-AE55-E1DB-B600AB1856AD}"/>
                </a:ext>
              </a:extLst>
            </p:cNvPr>
            <p:cNvSpPr/>
            <p:nvPr/>
          </p:nvSpPr>
          <p:spPr>
            <a:xfrm>
              <a:off x="8054711" y="3442854"/>
              <a:ext cx="367145" cy="34636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D58A53B7-FF5A-5F41-BDDE-1CEEC8BC75F7}"/>
                </a:ext>
              </a:extLst>
            </p:cNvPr>
            <p:cNvSpPr/>
            <p:nvPr/>
          </p:nvSpPr>
          <p:spPr>
            <a:xfrm>
              <a:off x="10411691" y="381001"/>
              <a:ext cx="942109" cy="1385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atient 1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676FB5C1-0DA2-8D8D-0C55-0099B8D41406}"/>
                </a:ext>
              </a:extLst>
            </p:cNvPr>
            <p:cNvSpPr/>
            <p:nvPr/>
          </p:nvSpPr>
          <p:spPr>
            <a:xfrm>
              <a:off x="10411690" y="3463635"/>
              <a:ext cx="942109" cy="1385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atient 1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2E07B5E6-1DAA-6173-2FF3-78493C5CC076}"/>
                </a:ext>
              </a:extLst>
            </p:cNvPr>
            <p:cNvSpPr/>
            <p:nvPr/>
          </p:nvSpPr>
          <p:spPr>
            <a:xfrm>
              <a:off x="10467102" y="1125681"/>
              <a:ext cx="768931" cy="1385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ather</a:t>
              </a: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18BF68BF-B9D0-8E34-4177-B1807DE56A1D}"/>
                </a:ext>
              </a:extLst>
            </p:cNvPr>
            <p:cNvSpPr/>
            <p:nvPr/>
          </p:nvSpPr>
          <p:spPr>
            <a:xfrm>
              <a:off x="10498278" y="4589318"/>
              <a:ext cx="768931" cy="1385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ather</a:t>
              </a: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49EBA47C-C5C4-2338-F48F-0A543B7F3600}"/>
                </a:ext>
              </a:extLst>
            </p:cNvPr>
            <p:cNvSpPr/>
            <p:nvPr/>
          </p:nvSpPr>
          <p:spPr>
            <a:xfrm>
              <a:off x="10411690" y="5379028"/>
              <a:ext cx="1052946" cy="353291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other</a:t>
              </a: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9FDCCEB0-9A4C-A7DA-97CF-4E08B1868482}"/>
                </a:ext>
              </a:extLst>
            </p:cNvPr>
            <p:cNvSpPr/>
            <p:nvPr/>
          </p:nvSpPr>
          <p:spPr>
            <a:xfrm>
              <a:off x="10512132" y="2060861"/>
              <a:ext cx="942109" cy="23553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othe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936291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0F554635-198F-997E-696C-2333638D9B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5927636"/>
              </p:ext>
            </p:extLst>
          </p:nvPr>
        </p:nvGraphicFramePr>
        <p:xfrm>
          <a:off x="1332414" y="117702"/>
          <a:ext cx="9527173" cy="3914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矩形 12">
            <a:extLst>
              <a:ext uri="{FF2B5EF4-FFF2-40B4-BE49-F238E27FC236}">
                <a16:creationId xmlns:a16="http://schemas.microsoft.com/office/drawing/2014/main" id="{7D83B0A0-91ED-7D91-A850-EB1456E0E7D1}"/>
              </a:ext>
            </a:extLst>
          </p:cNvPr>
          <p:cNvSpPr/>
          <p:nvPr/>
        </p:nvSpPr>
        <p:spPr>
          <a:xfrm>
            <a:off x="10699023" y="5643555"/>
            <a:ext cx="699655" cy="304800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Time</a:t>
            </a:r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9769D70E-CA27-1BF6-2682-690C971D085B}"/>
              </a:ext>
            </a:extLst>
          </p:cNvPr>
          <p:cNvCxnSpPr/>
          <p:nvPr/>
        </p:nvCxnSpPr>
        <p:spPr>
          <a:xfrm>
            <a:off x="4075611" y="783771"/>
            <a:ext cx="0" cy="661851"/>
          </a:xfrm>
          <a:prstGeom prst="straightConnector1">
            <a:avLst/>
          </a:prstGeom>
          <a:ln w="19050" cmpd="sng">
            <a:solidFill>
              <a:schemeClr val="tx1"/>
            </a:solidFill>
            <a:headEnd w="sm" len="sm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90D23CED-32D3-66E1-0C3D-E450697BA21A}"/>
              </a:ext>
            </a:extLst>
          </p:cNvPr>
          <p:cNvCxnSpPr/>
          <p:nvPr/>
        </p:nvCxnSpPr>
        <p:spPr>
          <a:xfrm>
            <a:off x="4093028" y="4297680"/>
            <a:ext cx="0" cy="661851"/>
          </a:xfrm>
          <a:prstGeom prst="straightConnector1">
            <a:avLst/>
          </a:prstGeom>
          <a:ln w="19050" cmpd="sng">
            <a:solidFill>
              <a:schemeClr val="tx1"/>
            </a:solidFill>
            <a:headEnd w="sm" len="sm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矩形 23">
            <a:extLst>
              <a:ext uri="{FF2B5EF4-FFF2-40B4-BE49-F238E27FC236}">
                <a16:creationId xmlns:a16="http://schemas.microsoft.com/office/drawing/2014/main" id="{B0791A05-71D2-13F3-D202-26277A056D6E}"/>
              </a:ext>
            </a:extLst>
          </p:cNvPr>
          <p:cNvSpPr/>
          <p:nvPr/>
        </p:nvSpPr>
        <p:spPr>
          <a:xfrm>
            <a:off x="2795452" y="421096"/>
            <a:ext cx="3370217" cy="45284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rst dose Tocilizumab 01-05-20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图表 11">
            <a:extLst>
              <a:ext uri="{FF2B5EF4-FFF2-40B4-BE49-F238E27FC236}">
                <a16:creationId xmlns:a16="http://schemas.microsoft.com/office/drawing/2014/main" id="{49D710A7-E48F-E91B-45F0-4312052ECD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3807896"/>
              </p:ext>
            </p:extLst>
          </p:nvPr>
        </p:nvGraphicFramePr>
        <p:xfrm>
          <a:off x="1271453" y="3193281"/>
          <a:ext cx="9814555" cy="34339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矩形 1">
            <a:extLst>
              <a:ext uri="{FF2B5EF4-FFF2-40B4-BE49-F238E27FC236}">
                <a16:creationId xmlns:a16="http://schemas.microsoft.com/office/drawing/2014/main" id="{B8E1587A-8555-6959-686E-5B3EFF826E35}"/>
              </a:ext>
            </a:extLst>
          </p:cNvPr>
          <p:cNvSpPr/>
          <p:nvPr/>
        </p:nvSpPr>
        <p:spPr>
          <a:xfrm>
            <a:off x="4197928" y="1007080"/>
            <a:ext cx="145472" cy="263237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A3363EC7-5388-8EFC-96E5-962713D9422E}"/>
              </a:ext>
            </a:extLst>
          </p:cNvPr>
          <p:cNvSpPr/>
          <p:nvPr/>
        </p:nvSpPr>
        <p:spPr>
          <a:xfrm>
            <a:off x="4197928" y="4214277"/>
            <a:ext cx="145472" cy="263237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27396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2B346E-B3A8-A346-1768-070620C73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536787D-884C-2FBA-2C93-6DB7828875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altLang="zh-CN" dirty="0"/>
              <a:t>Patient 2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471078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C9A70A49-8893-4338-6F57-4D7922E84A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801" y="245454"/>
            <a:ext cx="6213818" cy="181833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F551BE0-5BFE-3AB6-296A-0D26B10A89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8" y="2398960"/>
            <a:ext cx="6343196" cy="1739547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3ADA25E-4819-F23B-5867-123E268B81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9932" y="4504169"/>
            <a:ext cx="6078687" cy="1639824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F514A933-E73C-E8BE-23A1-F97F191DD8EA}"/>
              </a:ext>
            </a:extLst>
          </p:cNvPr>
          <p:cNvSpPr/>
          <p:nvPr/>
        </p:nvSpPr>
        <p:spPr>
          <a:xfrm>
            <a:off x="249932" y="616373"/>
            <a:ext cx="989588" cy="399627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atient 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623E6117-9CB7-2993-37B7-3EA317C669B0}"/>
              </a:ext>
            </a:extLst>
          </p:cNvPr>
          <p:cNvSpPr/>
          <p:nvPr/>
        </p:nvSpPr>
        <p:spPr>
          <a:xfrm>
            <a:off x="162561" y="2735719"/>
            <a:ext cx="1076959" cy="37324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ather</a:t>
            </a: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BA3ED2AC-8996-9BF0-505E-67CFD1A4C3CF}"/>
              </a:ext>
            </a:extLst>
          </p:cNvPr>
          <p:cNvSpPr/>
          <p:nvPr/>
        </p:nvSpPr>
        <p:spPr>
          <a:xfrm>
            <a:off x="159173" y="4791067"/>
            <a:ext cx="1080347" cy="30925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Mother</a:t>
            </a:r>
          </a:p>
        </p:txBody>
      </p:sp>
      <p:graphicFrame>
        <p:nvGraphicFramePr>
          <p:cNvPr id="27" name="图表 26">
            <a:extLst>
              <a:ext uri="{FF2B5EF4-FFF2-40B4-BE49-F238E27FC236}">
                <a16:creationId xmlns:a16="http://schemas.microsoft.com/office/drawing/2014/main" id="{0B29A2F8-6173-B13D-C940-FB80E9BD6D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9637156"/>
              </p:ext>
            </p:extLst>
          </p:nvPr>
        </p:nvGraphicFramePr>
        <p:xfrm>
          <a:off x="6604713" y="-365231"/>
          <a:ext cx="8121534" cy="33364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8" name="矩形 27">
            <a:extLst>
              <a:ext uri="{FF2B5EF4-FFF2-40B4-BE49-F238E27FC236}">
                <a16:creationId xmlns:a16="http://schemas.microsoft.com/office/drawing/2014/main" id="{4DA17973-7A56-DC52-BA3E-11A633AC4443}"/>
              </a:ext>
            </a:extLst>
          </p:cNvPr>
          <p:cNvSpPr/>
          <p:nvPr/>
        </p:nvSpPr>
        <p:spPr>
          <a:xfrm>
            <a:off x="14827382" y="5100321"/>
            <a:ext cx="956428" cy="45497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Time</a:t>
            </a:r>
            <a:endParaRPr lang="zh-CN" altLang="en-US" dirty="0"/>
          </a:p>
        </p:txBody>
      </p:sp>
      <p:graphicFrame>
        <p:nvGraphicFramePr>
          <p:cNvPr id="29" name="图表 28">
            <a:extLst>
              <a:ext uri="{FF2B5EF4-FFF2-40B4-BE49-F238E27FC236}">
                <a16:creationId xmlns:a16="http://schemas.microsoft.com/office/drawing/2014/main" id="{62C5BE32-3A04-AF4C-B89C-ECB883C26E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8629635"/>
              </p:ext>
            </p:extLst>
          </p:nvPr>
        </p:nvGraphicFramePr>
        <p:xfrm>
          <a:off x="6665924" y="3187072"/>
          <a:ext cx="7999112" cy="32079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0" name="矩形 29">
            <a:extLst>
              <a:ext uri="{FF2B5EF4-FFF2-40B4-BE49-F238E27FC236}">
                <a16:creationId xmlns:a16="http://schemas.microsoft.com/office/drawing/2014/main" id="{8727DC03-4939-EFFD-1927-9F91E35AF4DA}"/>
              </a:ext>
            </a:extLst>
          </p:cNvPr>
          <p:cNvSpPr/>
          <p:nvPr/>
        </p:nvSpPr>
        <p:spPr>
          <a:xfrm>
            <a:off x="114801" y="245454"/>
            <a:ext cx="266199" cy="37091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D1FFC27C-14F9-BA32-8F29-9C0CF4604965}"/>
              </a:ext>
            </a:extLst>
          </p:cNvPr>
          <p:cNvSpPr/>
          <p:nvPr/>
        </p:nvSpPr>
        <p:spPr>
          <a:xfrm>
            <a:off x="7707092" y="115412"/>
            <a:ext cx="266199" cy="37091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5E67D7CE-D545-7F73-26D8-1BBE354C3056}"/>
              </a:ext>
            </a:extLst>
          </p:cNvPr>
          <p:cNvCxnSpPr/>
          <p:nvPr/>
        </p:nvCxnSpPr>
        <p:spPr>
          <a:xfrm>
            <a:off x="11727873" y="3743280"/>
            <a:ext cx="0" cy="655538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758CF0C7-14F8-F51F-0787-B1E07B34AE75}"/>
              </a:ext>
            </a:extLst>
          </p:cNvPr>
          <p:cNvSpPr/>
          <p:nvPr/>
        </p:nvSpPr>
        <p:spPr>
          <a:xfrm>
            <a:off x="11798980" y="3620612"/>
            <a:ext cx="266199" cy="37091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0253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8</TotalTime>
  <Words>37</Words>
  <Application>Microsoft Office PowerPoint</Application>
  <PresentationFormat>宽屏</PresentationFormat>
  <Paragraphs>26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534085529@qq.com</dc:creator>
  <cp:lastModifiedBy>1534085529@qq.com</cp:lastModifiedBy>
  <cp:revision>30</cp:revision>
  <dcterms:created xsi:type="dcterms:W3CDTF">2022-06-16T08:09:46Z</dcterms:created>
  <dcterms:modified xsi:type="dcterms:W3CDTF">2023-12-19T12:02:57Z</dcterms:modified>
</cp:coreProperties>
</file>